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rits Berends" initials="FB" lastIdx="1" clrIdx="0">
    <p:extLst>
      <p:ext uri="{19B8F6BF-5375-455C-9EA6-DF929625EA0E}">
        <p15:presenceInfo xmlns:p15="http://schemas.microsoft.com/office/powerpoint/2012/main" userId="988ce62ec93472c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ED6F9"/>
    <a:srgbClr val="8C97EC"/>
    <a:srgbClr val="99B2DF"/>
    <a:srgbClr val="E49991"/>
    <a:srgbClr val="FFC9C2"/>
    <a:srgbClr val="7B0101"/>
    <a:srgbClr val="950101"/>
    <a:srgbClr val="FFA9A0"/>
    <a:srgbClr val="6F7AB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C998536-C737-469F-9383-CEB138CB3D9D}" v="1" dt="2021-04-12T20:45:22.63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63"/>
    <p:restoredTop sz="92947"/>
  </p:normalViewPr>
  <p:slideViewPr>
    <p:cSldViewPr snapToGrid="0">
      <p:cViewPr varScale="1">
        <p:scale>
          <a:sx n="111" d="100"/>
          <a:sy n="111" d="100"/>
        </p:scale>
        <p:origin x="89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ana Rodriguez" userId="a6c3ea7d12529229" providerId="LiveId" clId="{6C998536-C737-469F-9383-CEB138CB3D9D}"/>
    <pc:docChg chg="undo custSel modSld">
      <pc:chgData name="Deana Rodriguez" userId="a6c3ea7d12529229" providerId="LiveId" clId="{6C998536-C737-469F-9383-CEB138CB3D9D}" dt="2021-04-12T20:48:54.789" v="111" actId="122"/>
      <pc:docMkLst>
        <pc:docMk/>
      </pc:docMkLst>
      <pc:sldChg chg="addSp delSp modSp mod">
        <pc:chgData name="Deana Rodriguez" userId="a6c3ea7d12529229" providerId="LiveId" clId="{6C998536-C737-469F-9383-CEB138CB3D9D}" dt="2021-04-12T20:48:54.789" v="111" actId="122"/>
        <pc:sldMkLst>
          <pc:docMk/>
          <pc:sldMk cId="1219068927" sldId="257"/>
        </pc:sldMkLst>
        <pc:spChg chg="del mod">
          <ac:chgData name="Deana Rodriguez" userId="a6c3ea7d12529229" providerId="LiveId" clId="{6C998536-C737-469F-9383-CEB138CB3D9D}" dt="2021-04-12T20:27:06.413" v="42" actId="21"/>
          <ac:spMkLst>
            <pc:docMk/>
            <pc:sldMk cId="1219068927" sldId="257"/>
            <ac:spMk id="2" creationId="{00000000-0000-0000-0000-000000000000}"/>
          </ac:spMkLst>
        </pc:spChg>
        <pc:spChg chg="add mod">
          <ac:chgData name="Deana Rodriguez" userId="a6c3ea7d12529229" providerId="LiveId" clId="{6C998536-C737-469F-9383-CEB138CB3D9D}" dt="2021-04-12T20:48:54.789" v="111" actId="122"/>
          <ac:spMkLst>
            <pc:docMk/>
            <pc:sldMk cId="1219068927" sldId="257"/>
            <ac:spMk id="2" creationId="{105B06F1-4FC1-406F-9F3D-BE586F3167B6}"/>
          </ac:spMkLst>
        </pc:spChg>
        <pc:spChg chg="mod">
          <ac:chgData name="Deana Rodriguez" userId="a6c3ea7d12529229" providerId="LiveId" clId="{6C998536-C737-469F-9383-CEB138CB3D9D}" dt="2021-04-12T20:27:43.821" v="48" actId="14100"/>
          <ac:spMkLst>
            <pc:docMk/>
            <pc:sldMk cId="1219068927" sldId="257"/>
            <ac:spMk id="3" creationId="{AE806FAF-9D3E-49D9-BF3D-E9CCC82B4100}"/>
          </ac:spMkLst>
        </pc:spChg>
        <pc:spChg chg="mod">
          <ac:chgData name="Deana Rodriguez" userId="a6c3ea7d12529229" providerId="LiveId" clId="{6C998536-C737-469F-9383-CEB138CB3D9D}" dt="2021-04-12T20:34:46.198" v="85" actId="14100"/>
          <ac:spMkLst>
            <pc:docMk/>
            <pc:sldMk cId="1219068927" sldId="257"/>
            <ac:spMk id="4" creationId="{5C047ED4-52E3-4A2A-948B-20CE7D7233A4}"/>
          </ac:spMkLst>
        </pc:spChg>
        <pc:spChg chg="mod">
          <ac:chgData name="Deana Rodriguez" userId="a6c3ea7d12529229" providerId="LiveId" clId="{6C998536-C737-469F-9383-CEB138CB3D9D}" dt="2021-04-12T20:48:26.393" v="107" actId="14100"/>
          <ac:spMkLst>
            <pc:docMk/>
            <pc:sldMk cId="1219068927" sldId="257"/>
            <ac:spMk id="5" creationId="{57C6657B-C862-4624-AF23-0815F276EF35}"/>
          </ac:spMkLst>
        </pc:spChg>
        <pc:spChg chg="mod">
          <ac:chgData name="Deana Rodriguez" userId="a6c3ea7d12529229" providerId="LiveId" clId="{6C998536-C737-469F-9383-CEB138CB3D9D}" dt="2021-04-12T20:29:07.324" v="51" actId="14100"/>
          <ac:spMkLst>
            <pc:docMk/>
            <pc:sldMk cId="1219068927" sldId="257"/>
            <ac:spMk id="14" creationId="{40F199E0-EF0A-4852-8CD5-FCA17ED84623}"/>
          </ac:spMkLst>
        </pc:spChg>
        <pc:spChg chg="mod">
          <ac:chgData name="Deana Rodriguez" userId="a6c3ea7d12529229" providerId="LiveId" clId="{6C998536-C737-469F-9383-CEB138CB3D9D}" dt="2021-04-12T20:48:33.574" v="108" actId="1076"/>
          <ac:spMkLst>
            <pc:docMk/>
            <pc:sldMk cId="1219068927" sldId="257"/>
            <ac:spMk id="18" creationId="{F89B844B-5329-4EF8-A25F-1F177F64B210}"/>
          </ac:spMkLst>
        </pc:spChg>
        <pc:spChg chg="mod">
          <ac:chgData name="Deana Rodriguez" userId="a6c3ea7d12529229" providerId="LiveId" clId="{6C998536-C737-469F-9383-CEB138CB3D9D}" dt="2021-04-12T20:29:22.908" v="55" actId="14100"/>
          <ac:spMkLst>
            <pc:docMk/>
            <pc:sldMk cId="1219068927" sldId="257"/>
            <ac:spMk id="127" creationId="{00000000-0000-0000-0000-000000000000}"/>
          </ac:spMkLst>
        </pc:spChg>
        <pc:picChg chg="mod">
          <ac:chgData name="Deana Rodriguez" userId="a6c3ea7d12529229" providerId="LiveId" clId="{6C998536-C737-469F-9383-CEB138CB3D9D}" dt="2021-04-12T20:48:41.521" v="109" actId="1076"/>
          <ac:picMkLst>
            <pc:docMk/>
            <pc:sldMk cId="1219068927" sldId="257"/>
            <ac:picMk id="6" creationId="{E2FD73DB-5170-483D-8AED-73807F7EFBAA}"/>
          </ac:picMkLst>
        </pc:picChg>
        <pc:picChg chg="mod">
          <ac:chgData name="Deana Rodriguez" userId="a6c3ea7d12529229" providerId="LiveId" clId="{6C998536-C737-469F-9383-CEB138CB3D9D}" dt="2021-04-12T20:35:29.229" v="88" actId="1076"/>
          <ac:picMkLst>
            <pc:docMk/>
            <pc:sldMk cId="1219068927" sldId="257"/>
            <ac:picMk id="7" creationId="{9D7F0B6B-053D-4EF4-A94B-964FCCCABAE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4C72DB-605E-0F4B-BEFA-F419CD777762}" type="datetimeFigureOut">
              <a:rPr lang="en-US" smtClean="0"/>
              <a:t>7/1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032445-0623-A84C-A2C0-69350AC39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4099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ctr"/>
            <a:r>
              <a:rPr lang="en-US" dirty="0"/>
              <a:t>LU Biter, MMA Van </a:t>
            </a:r>
            <a:r>
              <a:rPr lang="en-US" dirty="0" err="1"/>
              <a:t>Buuren</a:t>
            </a:r>
            <a:r>
              <a:rPr lang="en-US" dirty="0"/>
              <a:t>, GHH </a:t>
            </a:r>
            <a:r>
              <a:rPr lang="en-US" dirty="0" err="1"/>
              <a:t>Mannaerts</a:t>
            </a:r>
            <a:endParaRPr lang="en-US" dirty="0"/>
          </a:p>
          <a:p>
            <a:pPr algn="ctr"/>
            <a:r>
              <a:rPr lang="en-US" dirty="0"/>
              <a:t>JA </a:t>
            </a:r>
            <a:r>
              <a:rPr lang="en-US" dirty="0" err="1"/>
              <a:t>Apers</a:t>
            </a:r>
            <a:r>
              <a:rPr lang="en-US" dirty="0"/>
              <a:t>, M </a:t>
            </a:r>
            <a:r>
              <a:rPr lang="en-US" dirty="0" err="1"/>
              <a:t>Dunkelgrun</a:t>
            </a:r>
            <a:r>
              <a:rPr lang="en-US" dirty="0"/>
              <a:t>, GHEJ </a:t>
            </a:r>
            <a:r>
              <a:rPr lang="en-US" dirty="0" err="1"/>
              <a:t>Vikgen</a:t>
            </a:r>
            <a:r>
              <a:rPr lang="en-US" dirty="0"/>
              <a:t>, </a:t>
            </a:r>
            <a:r>
              <a:rPr lang="en-US" i="1" dirty="0"/>
              <a:t>May 2017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032445-0623-A84C-A2C0-69350AC3936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8454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3EE756-DF6A-4713-89FB-98A46E28C7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C860C0B-2E9F-49F2-9460-46107BB63E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6825DCB-86FC-4DA3-AAA0-627B9BBD9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5987355-6512-4423-AC1B-44E24981C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1233452-DDA1-4B3F-9C13-132C5DEA4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2951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7F0807-81D0-4253-B234-B374B0C606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C57DABB-378F-4D89-A706-F66973DD9C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442D99-3C3A-4B78-BE35-4A3FB9255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E0E2A6A-BA6C-49EA-8ACD-3324BB111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4BB33F4-9B5D-430C-B6B8-2BF170C4B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3188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4087BF07-E783-4E4B-8E99-782AE0353A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20F25FB-97CC-44E1-A9BF-2361087D87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C3D29A0-66AF-4AC9-BDD4-CCEC78537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1B806D9-654B-4B39-ACBB-2178013F6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A6EF732-C326-4E32-BE60-3B42041F7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8302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0DCD913-2CE9-47F7-8DF5-B55ADD1012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00A6B60-4094-4F4D-BD34-EE380470B0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5FD9612-5AA2-4662-A788-6D5E9D836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53694D7-CE1C-425E-97DC-4AF93B823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25BF268-142F-4DBE-BB43-8764EE7CD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2147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7F7D608-CC5D-4254-A13D-6149D786B6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63DE456-BABE-4339-B81C-0221CB9A73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56B46DD-355D-47F9-89D6-3C8FD871F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932A418-F68D-40C2-B56B-EC7B0CC85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6304BAF-57B9-4258-97AA-43E4FA100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115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EDB117F-BC84-42A5-80C3-4D888B6091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3478E9A-D498-424D-9EE8-2B0E59BD94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19E52A5-B8D8-487B-B656-EFCE9EB0A8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CFA8D9E-F1A2-4B9C-9A32-A9D0783E5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7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982C0B3-010E-4F67-BAC5-B6226BEB7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754FCA9-6502-43C3-9124-9FD237787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3671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4E98D27-7505-46CB-B8CA-7760BED6A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20B258A-83CD-4E3A-A4DC-155F400B05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BE29E82-81E4-447F-9030-CF239E877C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954D1AA-0AC7-4212-8332-5D5D359139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5ABE488-E097-45CF-A269-E06BBEE5AB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77A92D5-E2FC-4B8D-B28A-733544C12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7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2B4839BF-D838-4C3D-9567-9797435B8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1C683122-6F71-40F3-9FE4-0E271C1DD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8601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FDB1BDF-B62F-4DD8-8A1C-0071710360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867A061-5397-43AE-857F-848316178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7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9BDDE2E-0059-4B34-A48B-D3C8D242C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0DB4436-B0AA-4133-9FCF-32D245D99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5690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A02C732-CCD5-4ADA-B6AD-A92323F50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7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D31A62A-4978-4089-8105-BDD96727D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F505B86-1899-4229-8FCF-493025701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654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5822F80-6FCE-432B-B81C-621EE802AE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738CBAF-9ED8-473F-9938-BC785CD39D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D2B786E-0C7B-4C02-9BF9-F64BB8017B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CC700F8-1C90-435C-8F29-C932B7D1E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7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94CDB35-1EDE-41BA-9492-286F1368D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60AF755-D296-4197-8C45-EDF1CDA93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5933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A7F0283-8A56-4501-A1BC-4CFA1C9717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41ADA50-9ECC-4627-8967-B457905C1E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0699504-8609-4515-AC65-4B9187F9A2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1EFFA4E-9FAB-4AB5-96AA-8E05FB8C9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14/07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1919DB2-E3CE-4DB6-8C6E-6DD387ABE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D2811A8-F934-493D-8B84-59CE2D22C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3737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08BE410-AACE-489A-830B-919842636C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A74C952-12DB-44E4-8E5F-CD7FAB1C85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3FEA6A1-94CC-4E43-9EB0-CB7BA1DD83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ACE20-333B-44FF-8048-BDE66E2D3417}" type="datetimeFigureOut">
              <a:rPr lang="it-IT" smtClean="0"/>
              <a:t>14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3ACA87-6133-4DF5-A554-934070FFF8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A6DE944-0076-43EB-8EE2-25BA726A93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9008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E806FAF-9D3E-49D9-BF3D-E9CCC82B41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046595"/>
            <a:ext cx="10515600" cy="4975667"/>
          </a:xfrm>
        </p:spPr>
        <p:txBody>
          <a:bodyPr/>
          <a:lstStyle/>
          <a:p>
            <a:endParaRPr lang="en-US" noProof="0" dirty="0"/>
          </a:p>
          <a:p>
            <a:endParaRPr lang="en-US" noProof="0" dirty="0"/>
          </a:p>
        </p:txBody>
      </p:sp>
      <p:sp>
        <p:nvSpPr>
          <p:cNvPr id="4" name="Rettangolo 3">
            <a:extLst>
              <a:ext uri="{FF2B5EF4-FFF2-40B4-BE49-F238E27FC236}">
                <a16:creationId xmlns:a16="http://schemas.microsoft.com/office/drawing/2014/main" id="{5C047ED4-52E3-4A2A-948B-20CE7D7233A4}"/>
              </a:ext>
            </a:extLst>
          </p:cNvPr>
          <p:cNvSpPr/>
          <p:nvPr/>
        </p:nvSpPr>
        <p:spPr>
          <a:xfrm>
            <a:off x="3888" y="833608"/>
            <a:ext cx="12198272" cy="4975667"/>
          </a:xfrm>
          <a:prstGeom prst="rect">
            <a:avLst/>
          </a:prstGeom>
          <a:solidFill>
            <a:srgbClr val="99B2D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noProof="0"/>
          </a:p>
        </p:txBody>
      </p:sp>
      <p:sp>
        <p:nvSpPr>
          <p:cNvPr id="5" name="Rettangolo 4">
            <a:extLst>
              <a:ext uri="{FF2B5EF4-FFF2-40B4-BE49-F238E27FC236}">
                <a16:creationId xmlns:a16="http://schemas.microsoft.com/office/drawing/2014/main" id="{57C6657B-C862-4624-AF23-0815F276EF35}"/>
              </a:ext>
            </a:extLst>
          </p:cNvPr>
          <p:cNvSpPr/>
          <p:nvPr/>
        </p:nvSpPr>
        <p:spPr>
          <a:xfrm>
            <a:off x="3958986" y="833608"/>
            <a:ext cx="4288076" cy="4975667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noProof="0" dirty="0"/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9D7F0B6B-053D-4EF4-A94B-964FCCCABA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46763" y="5986009"/>
            <a:ext cx="3425124" cy="714488"/>
          </a:xfrm>
          <a:prstGeom prst="rect">
            <a:avLst/>
          </a:prstGeom>
        </p:spPr>
      </p:pic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40F199E0-EF0A-4852-8CD5-FCA17ED84623}"/>
              </a:ext>
            </a:extLst>
          </p:cNvPr>
          <p:cNvSpPr txBox="1"/>
          <p:nvPr/>
        </p:nvSpPr>
        <p:spPr>
          <a:xfrm>
            <a:off x="67393" y="815762"/>
            <a:ext cx="3895804" cy="461665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sz="2400" b="1" noProof="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   METHODS</a:t>
            </a:r>
            <a:r>
              <a:rPr lang="en-US" sz="2400" b="1" noProof="0" dirty="0"/>
              <a:t>	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F89B844B-5329-4EF8-A25F-1F177F64B210}"/>
              </a:ext>
            </a:extLst>
          </p:cNvPr>
          <p:cNvSpPr txBox="1"/>
          <p:nvPr/>
        </p:nvSpPr>
        <p:spPr>
          <a:xfrm>
            <a:off x="4025304" y="815762"/>
            <a:ext cx="4175760" cy="461665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sz="2400" b="1" noProof="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ESULTS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E2FD73DB-5170-483D-8AED-73807F7EFBA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0113" y="5959626"/>
            <a:ext cx="2422604" cy="699863"/>
          </a:xfrm>
          <a:prstGeom prst="rect">
            <a:avLst/>
          </a:prstGeom>
          <a:ln>
            <a:noFill/>
          </a:ln>
        </p:spPr>
      </p:pic>
      <p:sp>
        <p:nvSpPr>
          <p:cNvPr id="127" name="Rectangle 126"/>
          <p:cNvSpPr/>
          <p:nvPr/>
        </p:nvSpPr>
        <p:spPr>
          <a:xfrm>
            <a:off x="8136810" y="815762"/>
            <a:ext cx="4065350" cy="461665"/>
          </a:xfrm>
          <a:prstGeom prst="rect">
            <a:avLst/>
          </a:prstGeom>
        </p:spPr>
        <p:txBody>
          <a:bodyPr wrap="square" anchor="b">
            <a:spAutoFit/>
          </a:bodyPr>
          <a:lstStyle/>
          <a:p>
            <a:pPr algn="ctr"/>
            <a:r>
              <a:rPr lang="en-US" sz="2400" b="1" noProof="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ONCLUSION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05B06F1-4FC1-406F-9F3D-BE586F3167B6}"/>
              </a:ext>
            </a:extLst>
          </p:cNvPr>
          <p:cNvSpPr txBox="1"/>
          <p:nvPr/>
        </p:nvSpPr>
        <p:spPr>
          <a:xfrm>
            <a:off x="2852929" y="5986009"/>
            <a:ext cx="5449824" cy="73866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1400" noProof="0" dirty="0"/>
          </a:p>
          <a:p>
            <a:pPr algn="ctr"/>
            <a:endParaRPr lang="en-US" sz="1400" noProof="0" dirty="0"/>
          </a:p>
          <a:p>
            <a:pPr algn="ctr"/>
            <a:endParaRPr lang="en-US" sz="1400" noProof="0" dirty="0"/>
          </a:p>
        </p:txBody>
      </p:sp>
      <p:sp>
        <p:nvSpPr>
          <p:cNvPr id="8" name="CasellaDiTesto 10">
            <a:extLst>
              <a:ext uri="{FF2B5EF4-FFF2-40B4-BE49-F238E27FC236}">
                <a16:creationId xmlns:a16="http://schemas.microsoft.com/office/drawing/2014/main" id="{7E841DD3-FD98-4EB0-9BD3-D2A17CABA7C9}"/>
              </a:ext>
            </a:extLst>
          </p:cNvPr>
          <p:cNvSpPr txBox="1"/>
          <p:nvPr/>
        </p:nvSpPr>
        <p:spPr>
          <a:xfrm>
            <a:off x="10160" y="65247"/>
            <a:ext cx="121818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noProof="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HYALURONAN AND ASSOCIATED BIOMARKERS: A LONGITUDINAL COHORT STUDY IN PATIENTS WITH OBESITY UNDERGOING GASTRIC BYPASS SURGERY</a:t>
            </a:r>
          </a:p>
        </p:txBody>
      </p:sp>
      <p:pic>
        <p:nvPicPr>
          <p:cNvPr id="10" name="Bild 9" descr="Grupp med människor kontur">
            <a:extLst>
              <a:ext uri="{FF2B5EF4-FFF2-40B4-BE49-F238E27FC236}">
                <a16:creationId xmlns:a16="http://schemas.microsoft.com/office/drawing/2014/main" id="{83BC4328-FBB8-08EF-ABC0-CCE72D23E8E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558095" y="1323851"/>
            <a:ext cx="914400" cy="914400"/>
          </a:xfrm>
          <a:prstGeom prst="rect">
            <a:avLst/>
          </a:prstGeom>
        </p:spPr>
      </p:pic>
      <p:sp>
        <p:nvSpPr>
          <p:cNvPr id="13" name="textruta 12">
            <a:extLst>
              <a:ext uri="{FF2B5EF4-FFF2-40B4-BE49-F238E27FC236}">
                <a16:creationId xmlns:a16="http://schemas.microsoft.com/office/drawing/2014/main" id="{EEF7A2EB-C4B1-CBAD-CB22-0DD2F95B69F6}"/>
              </a:ext>
            </a:extLst>
          </p:cNvPr>
          <p:cNvSpPr txBox="1"/>
          <p:nvPr/>
        </p:nvSpPr>
        <p:spPr>
          <a:xfrm>
            <a:off x="222611" y="2278573"/>
            <a:ext cx="366299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noProof="0" dirty="0"/>
              <a:t>Serum samples from patients undergoing </a:t>
            </a:r>
          </a:p>
          <a:p>
            <a:pPr algn="ctr"/>
            <a:r>
              <a:rPr lang="en-US" sz="1600" noProof="0" dirty="0"/>
              <a:t>gastric bypass surgery at 5 time points:</a:t>
            </a:r>
          </a:p>
        </p:txBody>
      </p:sp>
      <p:sp>
        <p:nvSpPr>
          <p:cNvPr id="15" name="textruta 14">
            <a:extLst>
              <a:ext uri="{FF2B5EF4-FFF2-40B4-BE49-F238E27FC236}">
                <a16:creationId xmlns:a16="http://schemas.microsoft.com/office/drawing/2014/main" id="{A5D70A9D-8FE7-98AC-E00F-980316235B68}"/>
              </a:ext>
            </a:extLst>
          </p:cNvPr>
          <p:cNvSpPr txBox="1"/>
          <p:nvPr/>
        </p:nvSpPr>
        <p:spPr>
          <a:xfrm>
            <a:off x="768270" y="3451372"/>
            <a:ext cx="24730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noProof="0" dirty="0"/>
              <a:t>Preoperative, day of surgery, </a:t>
            </a:r>
          </a:p>
          <a:p>
            <a:pPr algn="ctr"/>
            <a:r>
              <a:rPr lang="en-US" sz="1200" b="1" noProof="0" dirty="0"/>
              <a:t>1 month, 3 months, 6 months</a:t>
            </a:r>
          </a:p>
        </p:txBody>
      </p:sp>
      <p:sp>
        <p:nvSpPr>
          <p:cNvPr id="16" name="textruta 15">
            <a:extLst>
              <a:ext uri="{FF2B5EF4-FFF2-40B4-BE49-F238E27FC236}">
                <a16:creationId xmlns:a16="http://schemas.microsoft.com/office/drawing/2014/main" id="{6381C27C-7D38-C6EF-C822-3C36E3F26D8D}"/>
              </a:ext>
            </a:extLst>
          </p:cNvPr>
          <p:cNvSpPr txBox="1"/>
          <p:nvPr/>
        </p:nvSpPr>
        <p:spPr>
          <a:xfrm>
            <a:off x="-53819" y="2978008"/>
            <a:ext cx="41340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noProof="0" dirty="0"/>
              <a:t>96 patients recruited (76% female, mean age 41, mean BMI 41)</a:t>
            </a:r>
          </a:p>
        </p:txBody>
      </p:sp>
      <p:sp>
        <p:nvSpPr>
          <p:cNvPr id="29" name="Pil: nedåt 28">
            <a:extLst>
              <a:ext uri="{FF2B5EF4-FFF2-40B4-BE49-F238E27FC236}">
                <a16:creationId xmlns:a16="http://schemas.microsoft.com/office/drawing/2014/main" id="{48BC0263-8ECF-05E7-DE62-4F4A3E34439E}"/>
              </a:ext>
            </a:extLst>
          </p:cNvPr>
          <p:cNvSpPr/>
          <p:nvPr/>
        </p:nvSpPr>
        <p:spPr>
          <a:xfrm>
            <a:off x="1758494" y="3961717"/>
            <a:ext cx="508959" cy="388224"/>
          </a:xfrm>
          <a:prstGeom prst="down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noProof="0" dirty="0"/>
          </a:p>
        </p:txBody>
      </p:sp>
      <p:pic>
        <p:nvPicPr>
          <p:cNvPr id="96" name="Bildobjekt 95">
            <a:extLst>
              <a:ext uri="{FF2B5EF4-FFF2-40B4-BE49-F238E27FC236}">
                <a16:creationId xmlns:a16="http://schemas.microsoft.com/office/drawing/2014/main" id="{30962708-1DAB-70F8-4407-45B3D6C35E0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6396" y="1807415"/>
            <a:ext cx="1973014" cy="22367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2" name="Bildobjekt 101" descr="En bild som visar diagram, text, linje, Teckensnitt&#10;&#10;AI-genererat innehåll kan vara felaktigt.">
            <a:extLst>
              <a:ext uri="{FF2B5EF4-FFF2-40B4-BE49-F238E27FC236}">
                <a16:creationId xmlns:a16="http://schemas.microsoft.com/office/drawing/2014/main" id="{A98091ED-C1D1-0323-7289-72691F7B518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9306" y="1807415"/>
            <a:ext cx="2234025" cy="28951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5" name="Rektangel: rundade hörn 104">
            <a:extLst>
              <a:ext uri="{FF2B5EF4-FFF2-40B4-BE49-F238E27FC236}">
                <a16:creationId xmlns:a16="http://schemas.microsoft.com/office/drawing/2014/main" id="{20E87CC5-C95D-276C-E166-317C67985B7A}"/>
              </a:ext>
            </a:extLst>
          </p:cNvPr>
          <p:cNvSpPr/>
          <p:nvPr/>
        </p:nvSpPr>
        <p:spPr>
          <a:xfrm>
            <a:off x="3979306" y="1246923"/>
            <a:ext cx="4260103" cy="474779"/>
          </a:xfrm>
          <a:prstGeom prst="round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t"/>
          <a:lstStyle/>
          <a:p>
            <a:pPr algn="ctr"/>
            <a:r>
              <a:rPr lang="en-US" sz="1100" b="1" noProof="0" dirty="0"/>
              <a:t>A notable proportion (39.6%) of patients with pathological HA levels </a:t>
            </a:r>
          </a:p>
          <a:p>
            <a:pPr algn="ctr"/>
            <a:r>
              <a:rPr lang="en-US" sz="1100" b="1" noProof="0" dirty="0"/>
              <a:t>(&gt;120ng/mL) preoperatively. </a:t>
            </a:r>
          </a:p>
          <a:p>
            <a:pPr algn="ctr"/>
            <a:endParaRPr lang="en-US" sz="1050" noProof="0" dirty="0"/>
          </a:p>
        </p:txBody>
      </p:sp>
      <p:sp>
        <p:nvSpPr>
          <p:cNvPr id="106" name="Rektangel: rundade hörn 105">
            <a:extLst>
              <a:ext uri="{FF2B5EF4-FFF2-40B4-BE49-F238E27FC236}">
                <a16:creationId xmlns:a16="http://schemas.microsoft.com/office/drawing/2014/main" id="{9EDEDAC7-37A7-8E19-ACEB-8BC737F34BEA}"/>
              </a:ext>
            </a:extLst>
          </p:cNvPr>
          <p:cNvSpPr/>
          <p:nvPr/>
        </p:nvSpPr>
        <p:spPr>
          <a:xfrm>
            <a:off x="222611" y="4584697"/>
            <a:ext cx="3564385" cy="738664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b="1" noProof="0" dirty="0"/>
              <a:t>Biomarkers assessed: </a:t>
            </a:r>
          </a:p>
          <a:p>
            <a:pPr algn="ctr"/>
            <a:r>
              <a:rPr lang="en-US" sz="1200" noProof="0" dirty="0"/>
              <a:t>Hyaluronan (HA), CD44, MMP-2 and -9, </a:t>
            </a:r>
            <a:r>
              <a:rPr lang="en-US" sz="1200" noProof="0" dirty="0" err="1"/>
              <a:t>TNFɑ</a:t>
            </a:r>
            <a:r>
              <a:rPr lang="en-US" sz="1200" noProof="0" dirty="0"/>
              <a:t>, </a:t>
            </a:r>
          </a:p>
          <a:p>
            <a:pPr algn="ctr"/>
            <a:r>
              <a:rPr lang="en-US" sz="1200" noProof="0" dirty="0"/>
              <a:t> IL1β, IL6, IL10 </a:t>
            </a:r>
          </a:p>
        </p:txBody>
      </p:sp>
      <p:sp>
        <p:nvSpPr>
          <p:cNvPr id="107" name="Rektangel: rundade hörn 106">
            <a:extLst>
              <a:ext uri="{FF2B5EF4-FFF2-40B4-BE49-F238E27FC236}">
                <a16:creationId xmlns:a16="http://schemas.microsoft.com/office/drawing/2014/main" id="{0BC947BD-85F3-6CFA-8AD3-2E4E50F58F7A}"/>
              </a:ext>
            </a:extLst>
          </p:cNvPr>
          <p:cNvSpPr/>
          <p:nvPr/>
        </p:nvSpPr>
        <p:spPr>
          <a:xfrm>
            <a:off x="8635620" y="1701642"/>
            <a:ext cx="3062377" cy="3146403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noProof="0" dirty="0"/>
              <a:t>Pathological HA levels are common in patients with obesity.</a:t>
            </a:r>
          </a:p>
          <a:p>
            <a:endParaRPr lang="en-US" sz="1600" noProof="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noProof="0" dirty="0"/>
              <a:t>Increase in MMP-2 levels indicates postoperative remodeling of the extracellular matrix.</a:t>
            </a:r>
          </a:p>
          <a:p>
            <a:endParaRPr lang="en-US" sz="1600" noProof="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noProof="0" dirty="0"/>
              <a:t>Chronic inflammation seems to persist 6 months after surgery.</a:t>
            </a:r>
          </a:p>
        </p:txBody>
      </p:sp>
      <p:sp>
        <p:nvSpPr>
          <p:cNvPr id="108" name="Rektangel: rundade hörn 107">
            <a:extLst>
              <a:ext uri="{FF2B5EF4-FFF2-40B4-BE49-F238E27FC236}">
                <a16:creationId xmlns:a16="http://schemas.microsoft.com/office/drawing/2014/main" id="{17BF7D2D-67E6-7157-EC7E-758C7E2D73B1}"/>
              </a:ext>
            </a:extLst>
          </p:cNvPr>
          <p:cNvSpPr/>
          <p:nvPr/>
        </p:nvSpPr>
        <p:spPr>
          <a:xfrm>
            <a:off x="6266396" y="4124675"/>
            <a:ext cx="1934668" cy="1486402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noProof="0" dirty="0"/>
              <a:t>Patients with HA&gt;120 preoperatively </a:t>
            </a:r>
            <a:r>
              <a:rPr lang="en-US" sz="1100" b="1" noProof="0" dirty="0"/>
              <a:t>decreased </a:t>
            </a:r>
            <a:r>
              <a:rPr lang="en-US" sz="1100" noProof="0" dirty="0"/>
              <a:t>in HA levels at 6 months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noProof="0" dirty="0"/>
              <a:t>Patients with HA&lt;120 preoperatively </a:t>
            </a:r>
            <a:r>
              <a:rPr lang="en-US" sz="1100" b="1" noProof="0" dirty="0"/>
              <a:t>increased </a:t>
            </a:r>
            <a:r>
              <a:rPr lang="en-US" sz="1100" noProof="0" dirty="0"/>
              <a:t>in HA levels at 6 months.</a:t>
            </a:r>
          </a:p>
        </p:txBody>
      </p:sp>
      <p:sp>
        <p:nvSpPr>
          <p:cNvPr id="109" name="Rektangel: rundade hörn 108">
            <a:extLst>
              <a:ext uri="{FF2B5EF4-FFF2-40B4-BE49-F238E27FC236}">
                <a16:creationId xmlns:a16="http://schemas.microsoft.com/office/drawing/2014/main" id="{4118730F-1D5A-9DE1-9146-863DF7BF7024}"/>
              </a:ext>
            </a:extLst>
          </p:cNvPr>
          <p:cNvSpPr/>
          <p:nvPr/>
        </p:nvSpPr>
        <p:spPr>
          <a:xfrm>
            <a:off x="3958986" y="4721387"/>
            <a:ext cx="2307410" cy="1066424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noProof="0" dirty="0"/>
              <a:t>Mean HA and associated biomarkers (except IL-10) decreased at time of surgery but subsequently increased to baseline</a:t>
            </a:r>
            <a:r>
              <a:rPr lang="en-US" sz="1000" dirty="0"/>
              <a:t>. Mean levels of MMP-2 was higher at 6 months compared to preoperatively (and MMP-9 and IL6 lower).</a:t>
            </a:r>
            <a:endParaRPr lang="en-US" sz="1000" noProof="0" dirty="0"/>
          </a:p>
        </p:txBody>
      </p:sp>
    </p:spTree>
    <p:extLst>
      <p:ext uri="{BB962C8B-B14F-4D97-AF65-F5344CB8AC3E}">
        <p14:creationId xmlns:p14="http://schemas.microsoft.com/office/powerpoint/2010/main" val="12190689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68</TotalTime>
  <Words>226</Words>
  <Application>Microsoft Office PowerPoint</Application>
  <PresentationFormat>Bredbild</PresentationFormat>
  <Paragraphs>26</Paragraphs>
  <Slides>1</Slides>
  <Notes>1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.mazzarella</dc:creator>
  <cp:lastModifiedBy>David Thalén</cp:lastModifiedBy>
  <cp:revision>100</cp:revision>
  <dcterms:created xsi:type="dcterms:W3CDTF">2017-10-03T08:27:08Z</dcterms:created>
  <dcterms:modified xsi:type="dcterms:W3CDTF">2025-07-14T19:33:34Z</dcterms:modified>
</cp:coreProperties>
</file>